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154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27398\Desktop\endof%20life%20new%20proposal\EOL%20new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27398\Desktop\endof%20life%20new%20proposal\EOL%20new.xls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Qsorts G1HW'!$GM$3</c:f>
              <c:strCache>
                <c:ptCount val="1"/>
                <c:pt idx="0">
                  <c:v>Mean D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strRef>
              <c:f>'Qsorts G1HW'!$GL$56:$GL$102</c:f>
              <c:strCache>
                <c:ptCount val="47"/>
                <c:pt idx="0">
                  <c:v>Die at peak of life</c:v>
                </c:pt>
                <c:pt idx="1">
                  <c:v>Without body exposed</c:v>
                </c:pt>
                <c:pt idx="2">
                  <c:v>Receive medical information regularly</c:v>
                </c:pt>
                <c:pt idx="3">
                  <c:v>Doctor available to answer questions</c:v>
                </c:pt>
                <c:pt idx="4">
                  <c:v>Doctor to discuss with family present</c:v>
                </c:pt>
                <c:pt idx="5">
                  <c:v>Don't want to die alone</c:v>
                </c:pt>
                <c:pt idx="6">
                  <c:v>Family/friends, rather than the doctor, to inform</c:v>
                </c:pt>
                <c:pt idx="7">
                  <c:v>All treatments no matter the chances of success</c:v>
                </c:pt>
                <c:pt idx="8">
                  <c:v>Avoid financial burden to family/friends</c:v>
                </c:pt>
                <c:pt idx="9">
                  <c:v>Die at home</c:v>
                </c:pt>
                <c:pt idx="10">
                  <c:v>Referred to as a person not a disease/ number</c:v>
                </c:pt>
                <c:pt idx="11">
                  <c:v>Financial affairs in order </c:v>
                </c:pt>
                <c:pt idx="12">
                  <c:v>Die in hospital</c:v>
                </c:pt>
                <c:pt idx="13">
                  <c:v>Avoid emotional burden to family/friends</c:v>
                </c:pt>
                <c:pt idx="14">
                  <c:v>Inform me before my family</c:v>
                </c:pt>
                <c:pt idx="15">
                  <c:v>Resolve conflicts</c:v>
                </c:pt>
                <c:pt idx="16">
                  <c:v>Healthcare professionals trusty religious-wise</c:v>
                </c:pt>
                <c:pt idx="17">
                  <c:v>No life support with little hope </c:v>
                </c:pt>
                <c:pt idx="18">
                  <c:v>If in coma, no intensive care</c:v>
                </c:pt>
                <c:pt idx="19">
                  <c:v>Discuss dying fears with physician</c:v>
                </c:pt>
                <c:pt idx="20">
                  <c:v>Live longer regardless </c:v>
                </c:pt>
                <c:pt idx="21">
                  <c:v>Family/friends prepared to accept my death</c:v>
                </c:pt>
                <c:pt idx="22">
                  <c:v>No tubes inserted </c:v>
                </c:pt>
                <c:pt idx="23">
                  <c:v>Avoid financial burden to society</c:v>
                </c:pt>
                <c:pt idx="24">
                  <c:v>If I have a fatal illness, I don’t want to know</c:v>
                </c:pt>
                <c:pt idx="25">
                  <c:v>Clergy at my last moments</c:v>
                </c:pt>
                <c:pt idx="26">
                  <c:v>Free of pain</c:v>
                </c:pt>
                <c:pt idx="27">
                  <c:v>Die instantaneously</c:v>
                </c:pt>
                <c:pt idx="28">
                  <c:v>At peace with God</c:v>
                </c:pt>
                <c:pt idx="29">
                  <c:v>Say statement of faith</c:v>
                </c:pt>
                <c:pt idx="30">
                  <c:v>Die well dressed</c:v>
                </c:pt>
                <c:pt idx="31">
                  <c:v>Able to bathe and feed</c:v>
                </c:pt>
                <c:pt idx="32">
                  <c:v>Able to communictae</c:v>
                </c:pt>
                <c:pt idx="33">
                  <c:v>Maintain sense of humor</c:v>
                </c:pt>
                <c:pt idx="34">
                  <c:v>Receive medical care with compassion</c:v>
                </c:pt>
                <c:pt idx="35">
                  <c:v>Make my own medical decisions</c:v>
                </c:pt>
                <c:pt idx="36">
                  <c:v> Status confidential from family/friends</c:v>
                </c:pt>
                <c:pt idx="37">
                  <c:v>Family/friends with me </c:v>
                </c:pt>
                <c:pt idx="38">
                  <c:v>Able to control bowels</c:v>
                </c:pt>
                <c:pt idx="39">
                  <c:v>Able to control bladder</c:v>
                </c:pt>
                <c:pt idx="40">
                  <c:v>Maintain dignity </c:v>
                </c:pt>
                <c:pt idx="41">
                  <c:v>No difficulty breathing</c:v>
                </c:pt>
                <c:pt idx="42">
                  <c:v>Die clean</c:v>
                </c:pt>
                <c:pt idx="43">
                  <c:v>Religious death rituals respected </c:v>
                </c:pt>
                <c:pt idx="44">
                  <c:v>Discuss dying fears with family/friends</c:v>
                </c:pt>
                <c:pt idx="45">
                  <c:v>Free of anxiety</c:v>
                </c:pt>
                <c:pt idx="46">
                  <c:v>Free of depression</c:v>
                </c:pt>
              </c:strCache>
            </c:strRef>
          </c:cat>
          <c:val>
            <c:numRef>
              <c:f>'Qsorts G1HW'!$GM$56:$GM$102</c:f>
              <c:numCache>
                <c:formatCode>0.00</c:formatCode>
                <c:ptCount val="47"/>
                <c:pt idx="0">
                  <c:v>-0.83333333333333337</c:v>
                </c:pt>
                <c:pt idx="1">
                  <c:v>-0.83333333333333337</c:v>
                </c:pt>
                <c:pt idx="2">
                  <c:v>-0.8</c:v>
                </c:pt>
                <c:pt idx="3">
                  <c:v>-0.53333333333333333</c:v>
                </c:pt>
                <c:pt idx="4">
                  <c:v>-0.53333333333333333</c:v>
                </c:pt>
                <c:pt idx="5">
                  <c:v>-0.5</c:v>
                </c:pt>
                <c:pt idx="6">
                  <c:v>-0.4</c:v>
                </c:pt>
                <c:pt idx="7">
                  <c:v>-0.36666666666666664</c:v>
                </c:pt>
                <c:pt idx="8">
                  <c:v>-0.36666666666666664</c:v>
                </c:pt>
                <c:pt idx="9">
                  <c:v>-0.33333333333333331</c:v>
                </c:pt>
                <c:pt idx="10">
                  <c:v>-0.3</c:v>
                </c:pt>
                <c:pt idx="11">
                  <c:v>-0.3</c:v>
                </c:pt>
                <c:pt idx="12">
                  <c:v>-0.26666666666666666</c:v>
                </c:pt>
                <c:pt idx="13">
                  <c:v>-0.23333333333333334</c:v>
                </c:pt>
                <c:pt idx="14">
                  <c:v>-0.2</c:v>
                </c:pt>
                <c:pt idx="15">
                  <c:v>-0.2</c:v>
                </c:pt>
                <c:pt idx="16">
                  <c:v>-0.16666666666666666</c:v>
                </c:pt>
                <c:pt idx="17">
                  <c:v>-0.16666666666666666</c:v>
                </c:pt>
                <c:pt idx="18">
                  <c:v>-0.13333333333333333</c:v>
                </c:pt>
                <c:pt idx="19">
                  <c:v>-0.13333333333333333</c:v>
                </c:pt>
                <c:pt idx="20">
                  <c:v>-0.1</c:v>
                </c:pt>
                <c:pt idx="21">
                  <c:v>-3.3333333333333333E-2</c:v>
                </c:pt>
                <c:pt idx="22">
                  <c:v>0</c:v>
                </c:pt>
                <c:pt idx="23">
                  <c:v>0</c:v>
                </c:pt>
                <c:pt idx="24">
                  <c:v>6.6666666666666666E-2</c:v>
                </c:pt>
                <c:pt idx="25">
                  <c:v>6.6666666666666666E-2</c:v>
                </c:pt>
                <c:pt idx="26">
                  <c:v>0.1</c:v>
                </c:pt>
                <c:pt idx="27">
                  <c:v>0.1</c:v>
                </c:pt>
                <c:pt idx="28">
                  <c:v>0.1</c:v>
                </c:pt>
                <c:pt idx="29">
                  <c:v>0.13333333333333333</c:v>
                </c:pt>
                <c:pt idx="30">
                  <c:v>0.13333333333333333</c:v>
                </c:pt>
                <c:pt idx="31">
                  <c:v>0.16666666666666666</c:v>
                </c:pt>
                <c:pt idx="32">
                  <c:v>0.2</c:v>
                </c:pt>
                <c:pt idx="33">
                  <c:v>0.23333333333333334</c:v>
                </c:pt>
                <c:pt idx="34">
                  <c:v>0.3</c:v>
                </c:pt>
                <c:pt idx="35">
                  <c:v>0.3</c:v>
                </c:pt>
                <c:pt idx="36">
                  <c:v>0.33333333333333331</c:v>
                </c:pt>
                <c:pt idx="37">
                  <c:v>0.33333333333333331</c:v>
                </c:pt>
                <c:pt idx="38">
                  <c:v>0.33333333333333331</c:v>
                </c:pt>
                <c:pt idx="39">
                  <c:v>0.36666666666666664</c:v>
                </c:pt>
                <c:pt idx="40">
                  <c:v>0.4</c:v>
                </c:pt>
                <c:pt idx="41">
                  <c:v>0.56666666666666665</c:v>
                </c:pt>
                <c:pt idx="42">
                  <c:v>0.56666666666666665</c:v>
                </c:pt>
                <c:pt idx="43">
                  <c:v>0.56666666666666665</c:v>
                </c:pt>
                <c:pt idx="44">
                  <c:v>0.66666666666666663</c:v>
                </c:pt>
                <c:pt idx="45">
                  <c:v>0.83333333333333337</c:v>
                </c:pt>
                <c:pt idx="46">
                  <c:v>0.86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6064256"/>
        <c:axId val="75671232"/>
      </c:barChart>
      <c:catAx>
        <c:axId val="760642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75671232"/>
        <c:crosses val="autoZero"/>
        <c:auto val="1"/>
        <c:lblAlgn val="ctr"/>
        <c:lblOffset val="100"/>
        <c:noMultiLvlLbl val="0"/>
      </c:catAx>
      <c:valAx>
        <c:axId val="75671232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760642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Qsorts G1HW'!$GM$3</c:f>
              <c:strCache>
                <c:ptCount val="1"/>
                <c:pt idx="0">
                  <c:v>Mean D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strRef>
              <c:f>'Qsorts G1HW'!$GL$108:$GL$154</c:f>
              <c:strCache>
                <c:ptCount val="47"/>
                <c:pt idx="0">
                  <c:v>Live longer regardless </c:v>
                </c:pt>
                <c:pt idx="1">
                  <c:v>Die well dressed</c:v>
                </c:pt>
                <c:pt idx="2">
                  <c:v>Discuss dying fears with family/friends</c:v>
                </c:pt>
                <c:pt idx="3">
                  <c:v>All treatments no matter the chances of success</c:v>
                </c:pt>
                <c:pt idx="4">
                  <c:v>Healthcare professionals trusty religious-wise</c:v>
                </c:pt>
                <c:pt idx="5">
                  <c:v>Receive medical care with compassion</c:v>
                </c:pt>
                <c:pt idx="6">
                  <c:v>Die instantaneously</c:v>
                </c:pt>
                <c:pt idx="7">
                  <c:v>Family/friends, rather than the doctor, to inform</c:v>
                </c:pt>
                <c:pt idx="8">
                  <c:v>Don't want to die alone</c:v>
                </c:pt>
                <c:pt idx="9">
                  <c:v>Able to communictae</c:v>
                </c:pt>
                <c:pt idx="10">
                  <c:v>If I have a fatal illness, I don’t want to know</c:v>
                </c:pt>
                <c:pt idx="11">
                  <c:v>At peace with God</c:v>
                </c:pt>
                <c:pt idx="12">
                  <c:v>Free of anxiety</c:v>
                </c:pt>
                <c:pt idx="13">
                  <c:v>Avoid financial burden to family/friends</c:v>
                </c:pt>
                <c:pt idx="14">
                  <c:v>No life support with little hope </c:v>
                </c:pt>
                <c:pt idx="15">
                  <c:v>Doctor to discuss with family present</c:v>
                </c:pt>
                <c:pt idx="16">
                  <c:v>Discuss dying fears with physician</c:v>
                </c:pt>
                <c:pt idx="17">
                  <c:v>Make my own medical decisions</c:v>
                </c:pt>
                <c:pt idx="18">
                  <c:v>Receive medical information regularly</c:v>
                </c:pt>
                <c:pt idx="19">
                  <c:v>Family/friends with me </c:v>
                </c:pt>
                <c:pt idx="20">
                  <c:v>Maintain sense of humor</c:v>
                </c:pt>
                <c:pt idx="21">
                  <c:v>No tubes inserted </c:v>
                </c:pt>
                <c:pt idx="22">
                  <c:v>Inform me before my family</c:v>
                </c:pt>
                <c:pt idx="23">
                  <c:v>Maintain dignity </c:v>
                </c:pt>
                <c:pt idx="24">
                  <c:v>Free of pain</c:v>
                </c:pt>
                <c:pt idx="25">
                  <c:v>Able to control bowels</c:v>
                </c:pt>
                <c:pt idx="26">
                  <c:v>Say statement of faith</c:v>
                </c:pt>
                <c:pt idx="27">
                  <c:v>Referred to as a person not a disease/ number</c:v>
                </c:pt>
                <c:pt idx="28">
                  <c:v>Die in hospital</c:v>
                </c:pt>
                <c:pt idx="29">
                  <c:v>Religious death rituals respected </c:v>
                </c:pt>
                <c:pt idx="30">
                  <c:v>Without body exposed</c:v>
                </c:pt>
                <c:pt idx="31">
                  <c:v>If in coma, no intensive care</c:v>
                </c:pt>
                <c:pt idx="32">
                  <c:v>Die at home</c:v>
                </c:pt>
                <c:pt idx="33">
                  <c:v>Die clean</c:v>
                </c:pt>
                <c:pt idx="34">
                  <c:v>Doctor available to answer questions</c:v>
                </c:pt>
                <c:pt idx="35">
                  <c:v>Die at peak of life</c:v>
                </c:pt>
                <c:pt idx="36">
                  <c:v>Avoid financial burden to society</c:v>
                </c:pt>
                <c:pt idx="37">
                  <c:v>Resolve conflicts</c:v>
                </c:pt>
                <c:pt idx="38">
                  <c:v>No difficulty breathing</c:v>
                </c:pt>
                <c:pt idx="39">
                  <c:v>Clergy at my last moments</c:v>
                </c:pt>
                <c:pt idx="40">
                  <c:v> Status confidential from family/friends</c:v>
                </c:pt>
                <c:pt idx="41">
                  <c:v>Able to control bladder</c:v>
                </c:pt>
                <c:pt idx="42">
                  <c:v>Family/friends prepared to accept my death</c:v>
                </c:pt>
                <c:pt idx="43">
                  <c:v>Able to bathe and feed</c:v>
                </c:pt>
                <c:pt idx="44">
                  <c:v>Financial affairs in order </c:v>
                </c:pt>
                <c:pt idx="45">
                  <c:v>Avoid emotional burden to family/friends</c:v>
                </c:pt>
                <c:pt idx="46">
                  <c:v>Free of depression</c:v>
                </c:pt>
              </c:strCache>
            </c:strRef>
          </c:cat>
          <c:val>
            <c:numRef>
              <c:f>'Qsorts G1HW'!$GM$108:$GM$154</c:f>
              <c:numCache>
                <c:formatCode>0.00</c:formatCode>
                <c:ptCount val="47"/>
                <c:pt idx="0">
                  <c:v>-0.73333333333333328</c:v>
                </c:pt>
                <c:pt idx="1">
                  <c:v>-0.7</c:v>
                </c:pt>
                <c:pt idx="2">
                  <c:v>-0.6</c:v>
                </c:pt>
                <c:pt idx="3">
                  <c:v>-0.46666666666666667</c:v>
                </c:pt>
                <c:pt idx="4">
                  <c:v>-0.43333333333333335</c:v>
                </c:pt>
                <c:pt idx="5">
                  <c:v>-0.43333333333333335</c:v>
                </c:pt>
                <c:pt idx="6">
                  <c:v>-0.36666666666666664</c:v>
                </c:pt>
                <c:pt idx="7">
                  <c:v>-0.3</c:v>
                </c:pt>
                <c:pt idx="8">
                  <c:v>-0.3</c:v>
                </c:pt>
                <c:pt idx="9">
                  <c:v>-0.26666666666666666</c:v>
                </c:pt>
                <c:pt idx="10">
                  <c:v>-0.23333333333333334</c:v>
                </c:pt>
                <c:pt idx="11">
                  <c:v>-0.23333333333333334</c:v>
                </c:pt>
                <c:pt idx="12">
                  <c:v>-0.2</c:v>
                </c:pt>
                <c:pt idx="13">
                  <c:v>-0.16666666666666666</c:v>
                </c:pt>
                <c:pt idx="14">
                  <c:v>-0.13333333333333333</c:v>
                </c:pt>
                <c:pt idx="15">
                  <c:v>-0.13333333333333333</c:v>
                </c:pt>
                <c:pt idx="16">
                  <c:v>-0.1</c:v>
                </c:pt>
                <c:pt idx="17">
                  <c:v>-0.1</c:v>
                </c:pt>
                <c:pt idx="18">
                  <c:v>-0.1</c:v>
                </c:pt>
                <c:pt idx="19">
                  <c:v>-0.1</c:v>
                </c:pt>
                <c:pt idx="20">
                  <c:v>-0.1</c:v>
                </c:pt>
                <c:pt idx="21">
                  <c:v>-3.3333333333333333E-2</c:v>
                </c:pt>
                <c:pt idx="22">
                  <c:v>-3.3333333333333333E-2</c:v>
                </c:pt>
                <c:pt idx="23">
                  <c:v>-3.3333333333333333E-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3.3333333333333333E-2</c:v>
                </c:pt>
                <c:pt idx="29">
                  <c:v>6.6666666666666666E-2</c:v>
                </c:pt>
                <c:pt idx="30">
                  <c:v>6.6666666666666666E-2</c:v>
                </c:pt>
                <c:pt idx="31">
                  <c:v>0.1</c:v>
                </c:pt>
                <c:pt idx="32">
                  <c:v>0.13333333333333333</c:v>
                </c:pt>
                <c:pt idx="33">
                  <c:v>0.13333333333333333</c:v>
                </c:pt>
                <c:pt idx="34">
                  <c:v>0.16666666666666666</c:v>
                </c:pt>
                <c:pt idx="35">
                  <c:v>0.16666666666666666</c:v>
                </c:pt>
                <c:pt idx="36">
                  <c:v>0.2</c:v>
                </c:pt>
                <c:pt idx="37">
                  <c:v>0.23333333333333334</c:v>
                </c:pt>
                <c:pt idx="38">
                  <c:v>0.26666666666666666</c:v>
                </c:pt>
                <c:pt idx="39">
                  <c:v>0.26666666666666666</c:v>
                </c:pt>
                <c:pt idx="40">
                  <c:v>0.36666666666666664</c:v>
                </c:pt>
                <c:pt idx="41">
                  <c:v>0.4</c:v>
                </c:pt>
                <c:pt idx="42">
                  <c:v>0.56666666666666665</c:v>
                </c:pt>
                <c:pt idx="43">
                  <c:v>0.6</c:v>
                </c:pt>
                <c:pt idx="44">
                  <c:v>0.6333333333333333</c:v>
                </c:pt>
                <c:pt idx="45">
                  <c:v>0.8</c:v>
                </c:pt>
                <c:pt idx="46">
                  <c:v>1.100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6065792"/>
        <c:axId val="75672960"/>
      </c:barChart>
      <c:catAx>
        <c:axId val="760657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75672960"/>
        <c:crosses val="autoZero"/>
        <c:auto val="1"/>
        <c:lblAlgn val="ctr"/>
        <c:lblOffset val="100"/>
        <c:noMultiLvlLbl val="0"/>
      </c:catAx>
      <c:valAx>
        <c:axId val="75672960"/>
        <c:scaling>
          <c:orientation val="minMax"/>
          <c:max val="1"/>
          <c:min val="-1"/>
        </c:scaling>
        <c:delete val="0"/>
        <c:axPos val="b"/>
        <c:numFmt formatCode="0.0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76065792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614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6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06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94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969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160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160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55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593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49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8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DB257-00C2-4F25-919B-3FFB4422512D}" type="datetimeFigureOut">
              <a:rPr lang="en-US" smtClean="0"/>
              <a:t>1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C300A-FD77-4CFA-8A97-4218EA01C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437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8094619"/>
              </p:ext>
            </p:extLst>
          </p:nvPr>
        </p:nvGraphicFramePr>
        <p:xfrm>
          <a:off x="-76200" y="183854"/>
          <a:ext cx="4648200" cy="6490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4641757"/>
              </p:ext>
            </p:extLst>
          </p:nvPr>
        </p:nvGraphicFramePr>
        <p:xfrm>
          <a:off x="4598670" y="189392"/>
          <a:ext cx="4545330" cy="64792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01640" y="28575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572000" y="2857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8898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MAMI, MUHAMMAD MAHER</dc:creator>
  <cp:lastModifiedBy>HAMMAMI, MUHAMMAD MAHER</cp:lastModifiedBy>
  <cp:revision>3</cp:revision>
  <cp:lastPrinted>2018-01-18T06:31:14Z</cp:lastPrinted>
  <dcterms:created xsi:type="dcterms:W3CDTF">2018-01-18T05:50:06Z</dcterms:created>
  <dcterms:modified xsi:type="dcterms:W3CDTF">2018-01-18T06:32:22Z</dcterms:modified>
</cp:coreProperties>
</file>